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9" r:id="rId3"/>
    <p:sldId id="257" r:id="rId4"/>
  </p:sldIdLst>
  <p:sldSz cx="9906000" cy="6858000" type="A4"/>
  <p:notesSz cx="9872663" cy="6858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12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598"/>
    <p:restoredTop sz="95940" autoAdjust="0"/>
  </p:normalViewPr>
  <p:slideViewPr>
    <p:cSldViewPr>
      <p:cViewPr varScale="1">
        <p:scale>
          <a:sx n="156" d="100"/>
          <a:sy n="156" d="100"/>
        </p:scale>
        <p:origin x="200" y="992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742950" y="2130426"/>
            <a:ext cx="8420100" cy="1470025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485900" y="3886200"/>
            <a:ext cx="69342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306F74-157A-4127-9D30-592ADA882621}" type="datetimeFigureOut">
              <a:rPr lang="de-DE" smtClean="0"/>
              <a:t>01.08.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C3EF38-F5E7-490F-8776-4D8E3774863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885485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306F74-157A-4127-9D30-592ADA882621}" type="datetimeFigureOut">
              <a:rPr lang="de-DE" smtClean="0"/>
              <a:t>01.08.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C3EF38-F5E7-490F-8776-4D8E3774863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559633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7181850" y="274639"/>
            <a:ext cx="2228850" cy="5851525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95300" y="274639"/>
            <a:ext cx="6521450" cy="5851525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306F74-157A-4127-9D30-592ADA882621}" type="datetimeFigureOut">
              <a:rPr lang="de-DE" smtClean="0"/>
              <a:t>01.08.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C3EF38-F5E7-490F-8776-4D8E3774863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692492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306F74-157A-4127-9D30-592ADA882621}" type="datetimeFigureOut">
              <a:rPr lang="de-DE" smtClean="0"/>
              <a:t>01.08.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C3EF38-F5E7-490F-8776-4D8E3774863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294794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82506" y="4406901"/>
            <a:ext cx="84201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82506" y="2906713"/>
            <a:ext cx="84201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306F74-157A-4127-9D30-592ADA882621}" type="datetimeFigureOut">
              <a:rPr lang="de-DE" smtClean="0"/>
              <a:t>01.08.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C3EF38-F5E7-490F-8776-4D8E3774863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914107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95300" y="1600201"/>
            <a:ext cx="437515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5035550" y="1600201"/>
            <a:ext cx="437515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306F74-157A-4127-9D30-592ADA882621}" type="datetimeFigureOut">
              <a:rPr lang="de-DE" smtClean="0"/>
              <a:t>01.08.19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C3EF38-F5E7-490F-8776-4D8E3774863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095655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95300" y="1535113"/>
            <a:ext cx="437687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95300" y="2174875"/>
            <a:ext cx="437687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5032111" y="1535113"/>
            <a:ext cx="437859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5032111" y="2174875"/>
            <a:ext cx="437859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306F74-157A-4127-9D30-592ADA882621}" type="datetimeFigureOut">
              <a:rPr lang="de-DE" smtClean="0"/>
              <a:t>01.08.19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C3EF38-F5E7-490F-8776-4D8E3774863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531518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306F74-157A-4127-9D30-592ADA882621}" type="datetimeFigureOut">
              <a:rPr lang="de-DE" smtClean="0"/>
              <a:t>01.08.19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C3EF38-F5E7-490F-8776-4D8E3774863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233046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306F74-157A-4127-9D30-592ADA882621}" type="datetimeFigureOut">
              <a:rPr lang="de-DE" smtClean="0"/>
              <a:t>01.08.19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C3EF38-F5E7-490F-8776-4D8E3774863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884752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95300" y="273050"/>
            <a:ext cx="3259006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872971" y="273051"/>
            <a:ext cx="5537729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95300" y="1435101"/>
            <a:ext cx="3259006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306F74-157A-4127-9D30-592ADA882621}" type="datetimeFigureOut">
              <a:rPr lang="de-DE" smtClean="0"/>
              <a:t>01.08.19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C3EF38-F5E7-490F-8776-4D8E3774863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422113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941645" y="4800600"/>
            <a:ext cx="59436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941645" y="612775"/>
            <a:ext cx="59436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941645" y="5367338"/>
            <a:ext cx="59436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306F74-157A-4127-9D30-592ADA882621}" type="datetimeFigureOut">
              <a:rPr lang="de-DE" smtClean="0"/>
              <a:t>01.08.19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C3EF38-F5E7-490F-8776-4D8E3774863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829914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95300" y="1600201"/>
            <a:ext cx="89154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95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306F74-157A-4127-9D30-592ADA882621}" type="datetimeFigureOut">
              <a:rPr lang="de-DE" smtClean="0"/>
              <a:t>01.08.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384550" y="6356351"/>
            <a:ext cx="31369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7099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C3EF38-F5E7-490F-8776-4D8E37748634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753305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598537" y="548680"/>
            <a:ext cx="7344816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S1. Genome characteristics of the five </a:t>
            </a:r>
            <a:r>
              <a:rPr lang="en-GB" sz="1100" b="1" i="1" dirty="0">
                <a:latin typeface="Arial" panose="020B0604020202020204" pitchFamily="34" charset="0"/>
                <a:cs typeface="Arial" panose="020B0604020202020204" pitchFamily="34" charset="0"/>
              </a:rPr>
              <a:t>Gemmobacter</a:t>
            </a: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 genomes</a:t>
            </a:r>
            <a:endParaRPr lang="en-GB" sz="1100" dirty="0"/>
          </a:p>
        </p:txBody>
      </p:sp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3849063"/>
              </p:ext>
            </p:extLst>
          </p:nvPr>
        </p:nvGraphicFramePr>
        <p:xfrm>
          <a:off x="56456" y="1196752"/>
          <a:ext cx="9849547" cy="25298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00811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792088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864096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864096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792088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720080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648072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864096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1296144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792088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  <a:gridCol w="1208587">
                  <a:extLst>
                    <a:ext uri="{9D8B030D-6E8A-4147-A177-3AD203B41FA5}">
                      <a16:colId xmlns:a16="http://schemas.microsoft.com/office/drawing/2014/main" val="4211042547"/>
                    </a:ext>
                  </a:extLst>
                </a:gridCol>
              </a:tblGrid>
              <a:tr h="216000">
                <a:tc>
                  <a:txBody>
                    <a:bodyPr/>
                    <a:lstStyle/>
                    <a:p>
                      <a:pPr algn="l"/>
                      <a:r>
                        <a:rPr lang="de-DE" sz="100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rganism</a:t>
                      </a:r>
                      <a:endParaRPr lang="en-GB" sz="1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solation</a:t>
                      </a:r>
                    </a:p>
                  </a:txBody>
                  <a:tcPr marL="45720" marR="4572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de-DE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MG </a:t>
                      </a:r>
                      <a:r>
                        <a:rPr lang="de-DE" sz="100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ome</a:t>
                      </a:r>
                      <a:r>
                        <a:rPr lang="de-DE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ID</a:t>
                      </a:r>
                      <a:endParaRPr lang="en-GB" sz="1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de-DE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ome </a:t>
                      </a:r>
                      <a:r>
                        <a:rPr lang="de-DE" sz="100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ze</a:t>
                      </a:r>
                      <a:r>
                        <a:rPr lang="de-DE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</a:t>
                      </a:r>
                      <a:r>
                        <a:rPr lang="de-DE" sz="100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umber</a:t>
                      </a:r>
                      <a:r>
                        <a:rPr lang="de-DE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100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f</a:t>
                      </a:r>
                      <a:r>
                        <a:rPr lang="de-DE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total </a:t>
                      </a:r>
                      <a:r>
                        <a:rPr lang="de-DE" sz="100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ses</a:t>
                      </a:r>
                      <a:r>
                        <a:rPr lang="de-DE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en-GB" sz="1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de-DE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 </a:t>
                      </a:r>
                      <a:r>
                        <a:rPr lang="de-DE" sz="100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unt</a:t>
                      </a:r>
                      <a:endParaRPr lang="de-DE" sz="1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l"/>
                      <a:r>
                        <a:rPr lang="de-DE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de-DE" sz="100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umber</a:t>
                      </a:r>
                      <a:r>
                        <a:rPr lang="de-DE" sz="10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1000" baseline="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f</a:t>
                      </a:r>
                      <a:r>
                        <a:rPr lang="de-DE" sz="10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total genes)</a:t>
                      </a:r>
                      <a:endParaRPr lang="en-GB" sz="1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de-DE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S </a:t>
                      </a:r>
                      <a:r>
                        <a:rPr lang="de-DE" sz="100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unt</a:t>
                      </a:r>
                      <a:r>
                        <a:rPr lang="de-DE" sz="10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</a:t>
                      </a:r>
                      <a:r>
                        <a:rPr lang="de-DE" sz="1000" baseline="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umber</a:t>
                      </a:r>
                      <a:r>
                        <a:rPr lang="de-DE" sz="10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1000" baseline="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f</a:t>
                      </a:r>
                      <a:r>
                        <a:rPr lang="de-DE" sz="10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CDS genes)</a:t>
                      </a:r>
                      <a:endParaRPr lang="en-GB" sz="1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de-DE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RNA </a:t>
                      </a:r>
                      <a:r>
                        <a:rPr lang="de-DE" sz="100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unt</a:t>
                      </a:r>
                      <a:r>
                        <a:rPr lang="de-DE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</a:t>
                      </a:r>
                      <a:r>
                        <a:rPr lang="de-DE" sz="100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umber</a:t>
                      </a:r>
                      <a:r>
                        <a:rPr lang="de-DE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100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f</a:t>
                      </a:r>
                      <a:r>
                        <a:rPr lang="de-DE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rRNA genes)</a:t>
                      </a:r>
                      <a:endParaRPr lang="en-GB" sz="1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 coding genes with function prediction</a:t>
                      </a:r>
                    </a:p>
                  </a:txBody>
                  <a:tcPr marL="45720" marR="4572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 coding genes without function prediction</a:t>
                      </a:r>
                    </a:p>
                  </a:txBody>
                  <a:tcPr marL="45720" marR="4572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C content</a:t>
                      </a:r>
                    </a:p>
                    <a:p>
                      <a:pPr algn="l"/>
                      <a:r>
                        <a:rPr lang="en-GB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%]</a:t>
                      </a:r>
                    </a:p>
                  </a:txBody>
                  <a:tcPr marL="45720" marR="4572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ome Completeness [%] </a:t>
                      </a:r>
                    </a:p>
                  </a:txBody>
                  <a:tcPr marL="45720" marR="4572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l"/>
                      <a:r>
                        <a:rPr lang="de-DE" sz="1000" i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. </a:t>
                      </a:r>
                      <a:r>
                        <a:rPr lang="de-DE" sz="1000" i="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</a:t>
                      </a:r>
                      <a:r>
                        <a:rPr lang="de-DE" sz="1000" i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 LW-1</a:t>
                      </a:r>
                      <a:endParaRPr lang="en-GB" sz="1000" i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vile Cave</a:t>
                      </a:r>
                    </a:p>
                  </a:txBody>
                  <a:tcPr marL="45720" marR="4572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48501906</a:t>
                      </a:r>
                    </a:p>
                  </a:txBody>
                  <a:tcPr marL="45720" marR="4572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,344,434</a:t>
                      </a:r>
                    </a:p>
                  </a:txBody>
                  <a:tcPr marL="45720" marR="4572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,312</a:t>
                      </a:r>
                    </a:p>
                  </a:txBody>
                  <a:tcPr marL="45720" marR="4572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de-DE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,223</a:t>
                      </a:r>
                      <a:endParaRPr lang="en-GB" sz="1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de-DE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</a:t>
                      </a:r>
                      <a:endParaRPr lang="en-GB" sz="1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de-DE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,443</a:t>
                      </a:r>
                      <a:endParaRPr lang="en-GB" sz="1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de-DE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80</a:t>
                      </a:r>
                      <a:endParaRPr lang="en-GB" sz="1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4.77</a:t>
                      </a:r>
                    </a:p>
                  </a:txBody>
                  <a:tcPr marL="45720" marR="4572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.545</a:t>
                      </a:r>
                    </a:p>
                  </a:txBody>
                  <a:tcPr marL="45720" marR="4572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. </a:t>
                      </a:r>
                      <a:r>
                        <a:rPr lang="en-GB" sz="1000" i="1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eni</a:t>
                      </a:r>
                      <a:endParaRPr lang="en-GB" sz="1000" i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tivated Sludge</a:t>
                      </a:r>
                    </a:p>
                  </a:txBody>
                  <a:tcPr marL="45720" marR="4572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39367660</a:t>
                      </a:r>
                    </a:p>
                  </a:txBody>
                  <a:tcPr marL="45720" marR="4572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,135,347</a:t>
                      </a:r>
                    </a:p>
                  </a:txBody>
                  <a:tcPr marL="45720" marR="4572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,228</a:t>
                      </a:r>
                      <a:endParaRPr lang="en-GB" sz="1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de-DE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,122</a:t>
                      </a:r>
                      <a:endParaRPr lang="en-GB" sz="1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de-DE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GB" sz="1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de-DE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,856</a:t>
                      </a:r>
                      <a:endParaRPr lang="en-GB" sz="1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de-DE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266</a:t>
                      </a:r>
                      <a:endParaRPr lang="en-GB" sz="1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4.71</a:t>
                      </a:r>
                    </a:p>
                  </a:txBody>
                  <a:tcPr marL="45720" marR="4572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.697</a:t>
                      </a:r>
                    </a:p>
                  </a:txBody>
                  <a:tcPr marL="45720" marR="4572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. </a:t>
                      </a:r>
                      <a:r>
                        <a:rPr lang="en-GB" sz="1000" i="1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quatilis</a:t>
                      </a:r>
                      <a:endParaRPr lang="en-GB" sz="1000" i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quatic Pond</a:t>
                      </a:r>
                    </a:p>
                  </a:txBody>
                  <a:tcPr marL="45720" marR="4572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15840721</a:t>
                      </a:r>
                    </a:p>
                  </a:txBody>
                  <a:tcPr marL="45720" marR="4572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,964,038</a:t>
                      </a:r>
                    </a:p>
                  </a:txBody>
                  <a:tcPr marL="45720" marR="4572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,918</a:t>
                      </a:r>
                    </a:p>
                  </a:txBody>
                  <a:tcPr marL="45720" marR="4572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de-DE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,856</a:t>
                      </a:r>
                      <a:endParaRPr lang="en-GB" sz="1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de-DE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en-GB" sz="1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de-DE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,105</a:t>
                      </a:r>
                      <a:endParaRPr lang="en-GB" sz="1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de-DE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51</a:t>
                      </a:r>
                      <a:endParaRPr lang="en-GB" sz="1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5.06</a:t>
                      </a:r>
                    </a:p>
                  </a:txBody>
                  <a:tcPr marL="45720" marR="4572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.394</a:t>
                      </a:r>
                    </a:p>
                  </a:txBody>
                  <a:tcPr marL="45720" marR="4572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. </a:t>
                      </a:r>
                      <a:r>
                        <a:rPr lang="en-GB" sz="1000" i="1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ctariphilus</a:t>
                      </a:r>
                      <a:r>
                        <a:rPr lang="en-GB" sz="1000" i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</a:txBody>
                  <a:tcPr marL="45720" marR="4572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tivated Sludge</a:t>
                      </a:r>
                    </a:p>
                  </a:txBody>
                  <a:tcPr marL="45720" marR="4572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24614723</a:t>
                      </a:r>
                    </a:p>
                  </a:txBody>
                  <a:tcPr marL="45720" marR="4572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,523,636</a:t>
                      </a:r>
                    </a:p>
                  </a:txBody>
                  <a:tcPr marL="45720" marR="4572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,462</a:t>
                      </a:r>
                    </a:p>
                  </a:txBody>
                  <a:tcPr marL="45720" marR="4572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de-DE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,405</a:t>
                      </a:r>
                      <a:endParaRPr lang="en-GB" sz="1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de-DE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en-GB" sz="1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de-DE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,394</a:t>
                      </a:r>
                      <a:endParaRPr lang="en-GB" sz="1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de-DE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011</a:t>
                      </a:r>
                      <a:endParaRPr lang="en-GB" sz="1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6.19</a:t>
                      </a:r>
                    </a:p>
                  </a:txBody>
                  <a:tcPr marL="45720" marR="4572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.318</a:t>
                      </a:r>
                    </a:p>
                  </a:txBody>
                  <a:tcPr marL="45720" marR="4572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l"/>
                      <a:r>
                        <a:rPr lang="en-GB" sz="1000" i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. </a:t>
                      </a:r>
                      <a:r>
                        <a:rPr lang="en-GB" sz="1000" i="1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gaterium</a:t>
                      </a:r>
                      <a:r>
                        <a:rPr lang="en-GB" sz="1000" i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</a:txBody>
                  <a:tcPr marL="45720" marR="4572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aweed</a:t>
                      </a:r>
                    </a:p>
                  </a:txBody>
                  <a:tcPr marL="45720" marR="4572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81813556</a:t>
                      </a:r>
                    </a:p>
                  </a:txBody>
                  <a:tcPr marL="45720" marR="4572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,168,088</a:t>
                      </a:r>
                    </a:p>
                  </a:txBody>
                  <a:tcPr marL="45720" marR="4572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,075</a:t>
                      </a:r>
                    </a:p>
                  </a:txBody>
                  <a:tcPr marL="45720" marR="4572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de-DE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,020</a:t>
                      </a:r>
                      <a:endParaRPr lang="en-GB" sz="1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de-DE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GB" sz="1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de-DE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,273</a:t>
                      </a:r>
                      <a:endParaRPr lang="en-GB" sz="1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de-DE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47</a:t>
                      </a:r>
                      <a:endParaRPr lang="en-GB" sz="1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4.90</a:t>
                      </a:r>
                    </a:p>
                  </a:txBody>
                  <a:tcPr marL="45720" marR="4572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8.611</a:t>
                      </a:r>
                    </a:p>
                  </a:txBody>
                  <a:tcPr marL="45720" marR="4572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56000367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68052365"/>
              </p:ext>
            </p:extLst>
          </p:nvPr>
        </p:nvGraphicFramePr>
        <p:xfrm>
          <a:off x="272480" y="692696"/>
          <a:ext cx="9289032" cy="6015119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4392488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16024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736304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182482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</a:t>
                      </a:r>
                    </a:p>
                  </a:txBody>
                  <a:tcPr marL="6477" marR="6477" marT="64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hort name</a:t>
                      </a:r>
                    </a:p>
                  </a:txBody>
                  <a:tcPr marL="6477" marR="6477" marT="64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cession number (NCBI)</a:t>
                      </a:r>
                    </a:p>
                  </a:txBody>
                  <a:tcPr marL="6477" marR="6477" marT="64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82482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mmonium transporter 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477" marR="6477" marT="64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noProof="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mtB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477" marR="6477" marT="64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P_054302626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477" marR="6477" marT="64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82482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rbon monoxide dehydrogenase 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477" marR="6477" marT="64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x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477" marR="6477" marT="64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RS16390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477" marR="6477" marT="64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82482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MA dehydrogenase 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477" marR="6477" marT="64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noProof="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md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477" marR="6477" marT="64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57961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477" marR="6477" marT="64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58177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MA monooxygenase 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477" marR="6477" marT="647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noProof="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mmD</a:t>
                      </a:r>
                      <a:r>
                        <a:rPr lang="en-GB" sz="110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</a:t>
                      </a:r>
                      <a:r>
                        <a:rPr lang="en-GB" sz="1100" u="none" strike="noStrike" noProof="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mmA</a:t>
                      </a:r>
                      <a:r>
                        <a:rPr lang="en-GB" sz="110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</a:t>
                      </a:r>
                    </a:p>
                    <a:p>
                      <a:pPr algn="l" fontAlgn="b"/>
                      <a:r>
                        <a:rPr lang="en-GB" sz="1100" u="none" strike="noStrike" noProof="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mmB</a:t>
                      </a:r>
                      <a:r>
                        <a:rPr lang="en-GB" sz="110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DMMC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477" marR="6477" marT="64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P_011047316, WP_044028112, WP_011047318, WP_011047319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477" marR="6477" marT="64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82482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maldehyde-activating enzyme 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477" marR="6477" marT="64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e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477" marR="6477" marT="64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GJ23184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477" marR="6477" marT="64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82482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noProof="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mate</a:t>
                      </a:r>
                      <a:r>
                        <a:rPr lang="en-GB" sz="110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dehydrogenase 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477" marR="6477" marT="64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noProof="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dh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477" marR="6477" marT="64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P_054303846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477" marR="6477" marT="64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82482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myl-H</a:t>
                      </a:r>
                      <a:r>
                        <a:rPr lang="en-GB" sz="1100" u="none" strike="noStrike" baseline="-25000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r>
                        <a:rPr lang="en-GB" sz="110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 </a:t>
                      </a:r>
                      <a:r>
                        <a:rPr lang="en-GB" sz="1100" u="none" strike="noStrike" noProof="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formylase</a:t>
                      </a:r>
                      <a:r>
                        <a:rPr lang="en-GB" sz="110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477" marR="6477" marT="64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noProof="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urU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477" marR="6477" marT="64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P_028029509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477" marR="6477" marT="64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82482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myl-H</a:t>
                      </a:r>
                      <a:r>
                        <a:rPr lang="en-GB" sz="1100" u="none" strike="noStrike" baseline="-25000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r>
                        <a:rPr lang="en-GB" sz="110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 </a:t>
                      </a:r>
                      <a:r>
                        <a:rPr lang="en-GB" sz="1100" u="none" strike="noStrike" noProof="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nthetase</a:t>
                      </a:r>
                      <a:r>
                        <a:rPr lang="en-GB" sz="110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477" marR="6477" marT="64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noProof="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hs</a:t>
                      </a:r>
                      <a:r>
                        <a:rPr lang="en-GB" sz="110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</a:t>
                      </a:r>
                      <a:r>
                        <a:rPr lang="en-GB" sz="1100" u="none" strike="noStrike" noProof="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tfL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477" marR="6477" marT="64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83WS0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477" marR="6477" marT="64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82482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noProof="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mylmethanofuran</a:t>
                      </a:r>
                      <a:r>
                        <a:rPr lang="en-GB" sz="110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dehydrogenase 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477" marR="6477" marT="64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noProof="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mdA</a:t>
                      </a:r>
                      <a:r>
                        <a:rPr lang="en-GB" sz="110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</a:t>
                      </a:r>
                      <a:r>
                        <a:rPr lang="en-GB" sz="1100" u="none" strike="noStrike" noProof="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mdB</a:t>
                      </a:r>
                      <a:r>
                        <a:rPr lang="en-GB" sz="110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</a:t>
                      </a:r>
                      <a:r>
                        <a:rPr lang="en-GB" sz="1100" u="none" strike="noStrike" noProof="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mdC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477" marR="6477" marT="64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F30065, CAF30067, CAF30066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477" marR="6477" marT="64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82482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mylmethanofuran-H</a:t>
                      </a:r>
                      <a:r>
                        <a:rPr lang="en-GB" sz="1100" u="none" strike="noStrike" baseline="-25000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r>
                        <a:rPr lang="en-GB" sz="110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PT-N-formyltransferase 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477" marR="6477" marT="64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noProof="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tr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477" marR="6477" marT="64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KJ40646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477" marR="6477" marT="64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82482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lutamine </a:t>
                      </a:r>
                      <a:r>
                        <a:rPr lang="en-GB" sz="1100" u="none" strike="noStrike" noProof="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nthetase</a:t>
                      </a:r>
                      <a:r>
                        <a:rPr lang="en-GB" sz="110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477" marR="6477" marT="64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noProof="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luL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477" marR="6477" marT="64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P_054301068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477" marR="6477" marT="64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82482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lutamine:2-oxoglutarate aminotransferase (glutamate synthase) 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477" marR="6477" marT="64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noProof="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lxB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477" marR="6477" marT="64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HP89794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477" marR="6477" marT="64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82482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lutathione-dependent formaldehyde dehydrogenase 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477" marR="6477" marT="64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noProof="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hI</a:t>
                      </a:r>
                      <a:r>
                        <a:rPr lang="en-GB" sz="110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</a:t>
                      </a:r>
                      <a:r>
                        <a:rPr lang="en-GB" sz="1100" u="none" strike="noStrike" noProof="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lhA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477" marR="6477" marT="64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P_352634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477" marR="6477" marT="64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182482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MA </a:t>
                      </a:r>
                      <a:r>
                        <a:rPr lang="en-GB" sz="1100" u="none" strike="noStrike" noProof="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nthetase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477" marR="6477" marT="64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noProof="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maS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477" marR="6477" marT="64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M083625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477" marR="6477" marT="64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182482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SH-dependent formaldehyde-activating enzyme 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477" marR="6477" marT="64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noProof="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fa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477" marR="6477" marT="64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P_011746365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477" marR="6477" marT="64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182482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thanol dehydrogenase-like protein 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477" marR="6477" marT="64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XoxF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477" marR="6477" marT="64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S40517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477" marR="6477" marT="64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182482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thanol</a:t>
                      </a:r>
                      <a:r>
                        <a:rPr lang="en-GB" sz="1100" b="0" i="0" u="none" strike="noStrike" baseline="0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dehydrogenase subunit 1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477" marR="6477" marT="64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xaF</a:t>
                      </a:r>
                    </a:p>
                  </a:txBody>
                  <a:tcPr marL="6477" marR="6477" marT="64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16027</a:t>
                      </a:r>
                    </a:p>
                  </a:txBody>
                  <a:tcPr marL="6477" marR="6477" marT="64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182482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thenyl-H</a:t>
                      </a:r>
                      <a:r>
                        <a:rPr lang="en-GB" sz="1100" u="none" strike="noStrike" baseline="-25000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r>
                        <a:rPr lang="en-GB" sz="110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 </a:t>
                      </a:r>
                      <a:r>
                        <a:rPr lang="en-GB" sz="1100" u="none" strike="noStrike" noProof="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yclohydrolase</a:t>
                      </a:r>
                      <a:r>
                        <a:rPr lang="en-GB" sz="110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477" marR="6477" marT="64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noProof="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chA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477" marR="6477" marT="64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49135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477" marR="6477" marT="64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182482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thenyl-H</a:t>
                      </a:r>
                      <a:r>
                        <a:rPr lang="en-GB" sz="1100" u="none" strike="noStrike" baseline="-25000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r>
                        <a:rPr lang="en-GB" sz="110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PT </a:t>
                      </a:r>
                      <a:r>
                        <a:rPr lang="en-GB" sz="1100" u="none" strike="noStrike" noProof="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yclohydrolase</a:t>
                      </a:r>
                      <a:r>
                        <a:rPr lang="en-GB" sz="110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477" marR="6477" marT="64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noProof="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chA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477" marR="6477" marT="64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Q8KMJ5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477" marR="6477" marT="64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182482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thylene-H</a:t>
                      </a:r>
                      <a:r>
                        <a:rPr lang="en-GB" sz="1100" u="none" strike="noStrike" baseline="-25000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r>
                        <a:rPr lang="en-GB" sz="110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 dehydrogenase 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477" marR="6477" marT="64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noProof="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tdA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477" marR="6477" marT="64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D13312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477" marR="6477" marT="64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182482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thylene-H</a:t>
                      </a:r>
                      <a:r>
                        <a:rPr lang="en-GB" sz="1100" u="none" strike="noStrike" baseline="-25000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r>
                        <a:rPr lang="en-GB" sz="110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 dehydrogenase/ </a:t>
                      </a:r>
                      <a:r>
                        <a:rPr lang="en-GB" sz="1100" u="none" strike="noStrike" noProof="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yclohydrolase</a:t>
                      </a:r>
                      <a:r>
                        <a:rPr lang="en-GB" sz="110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477" marR="6477" marT="64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noProof="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lD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477" marR="6477" marT="64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NX40634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477" marR="6477" marT="64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182482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thylene-H</a:t>
                      </a:r>
                      <a:r>
                        <a:rPr lang="en-GB" sz="1100" u="none" strike="noStrike" baseline="-25000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r>
                        <a:rPr lang="en-GB" sz="110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TP dehydrogenase 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477" marR="6477" marT="64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noProof="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tdB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477" marR="6477" marT="64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D13313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477" marR="6477" marT="64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182482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MA dehydrogenase large subunit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477" marR="6477" marT="64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noProof="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uG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477" marR="6477" marT="64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P_082401055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477" marR="6477" marT="64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182482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MA dehydrogenase small subunit 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477" marR="6477" marT="64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noProof="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uA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477" marR="6477" marT="64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F03760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477" marR="6477" marT="64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  <a:tr h="182482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-methyl-glutamate dehydrogenase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477" marR="6477" marT="64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noProof="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gdA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477" marR="6477" marT="64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PX83758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477" marR="6477" marT="64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5"/>
                  </a:ext>
                </a:extLst>
              </a:tr>
              <a:tr h="182482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-methyl-glutamate synthase 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477" marR="6477" marT="64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noProof="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gsA</a:t>
                      </a:r>
                      <a:r>
                        <a:rPr lang="en-GB" sz="110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</a:t>
                      </a:r>
                      <a:r>
                        <a:rPr lang="en-GB" sz="1100" u="none" strike="noStrike" noProof="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gsB</a:t>
                      </a:r>
                      <a:r>
                        <a:rPr lang="en-GB" sz="110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</a:t>
                      </a:r>
                      <a:r>
                        <a:rPr lang="en-GB" sz="1100" u="none" strike="noStrike" noProof="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gsC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477" marR="6477" marT="64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GM86398, KGM86397, KGM86396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477" marR="6477" marT="64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6"/>
                  </a:ext>
                </a:extLst>
              </a:tr>
              <a:tr h="182482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-formyl-glutathione hydrolase 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477" marR="6477" marT="64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noProof="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ghA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477" marR="6477" marT="64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P_001967351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477" marR="6477" marT="64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7"/>
                  </a:ext>
                </a:extLst>
              </a:tr>
              <a:tr h="182482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MA dehydrogenase 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477" marR="6477" marT="64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noProof="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md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477" marR="6477" marT="64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G35545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477" marR="6477" marT="64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8"/>
                  </a:ext>
                </a:extLst>
              </a:tr>
              <a:tr h="182482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MA methyltransferase 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477" marR="6477" marT="64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noProof="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ttB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477" marR="6477" marT="64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93658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477" marR="6477" marT="64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29"/>
                  </a:ext>
                </a:extLst>
              </a:tr>
              <a:tr h="182482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MA monooxygenase 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477" marR="6477" marT="64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noProof="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mm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477" marR="6477" marT="64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V94838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477" marR="6477" marT="64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30"/>
                  </a:ext>
                </a:extLst>
              </a:tr>
              <a:tr h="182482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MAO demethylase 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477" marR="6477" marT="64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noProof="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dm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477" marR="6477" marT="64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noProof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K52488</a:t>
                      </a:r>
                      <a:endParaRPr lang="en-GB" sz="110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477" marR="6477" marT="6477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31"/>
                  </a:ext>
                </a:extLst>
              </a:tr>
            </a:tbl>
          </a:graphicData>
        </a:graphic>
      </p:graphicFrame>
      <p:sp>
        <p:nvSpPr>
          <p:cNvPr id="5" name="Rectangle 4"/>
          <p:cNvSpPr/>
          <p:nvPr/>
        </p:nvSpPr>
        <p:spPr>
          <a:xfrm>
            <a:off x="200472" y="287070"/>
            <a:ext cx="7344816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S2. List of query protein sequences used for the genome comparison</a:t>
            </a:r>
            <a:endParaRPr lang="en-GB" sz="1100" dirty="0"/>
          </a:p>
        </p:txBody>
      </p:sp>
    </p:spTree>
    <p:extLst>
      <p:ext uri="{BB962C8B-B14F-4D97-AF65-F5344CB8AC3E}">
        <p14:creationId xmlns:p14="http://schemas.microsoft.com/office/powerpoint/2010/main" val="148916816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465145" y="189801"/>
            <a:ext cx="916838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err="1">
                <a:latin typeface="Arial" charset="0"/>
                <a:ea typeface="Arial" charset="0"/>
                <a:cs typeface="Arial" charset="0"/>
              </a:rPr>
              <a:t>SupplementaryTable</a:t>
            </a:r>
            <a:r>
              <a:rPr lang="en-US" sz="1100" b="1" dirty="0">
                <a:latin typeface="Arial" charset="0"/>
                <a:ea typeface="Arial" charset="0"/>
                <a:cs typeface="Arial" charset="0"/>
              </a:rPr>
              <a:t> S3.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Average nucleotide identity (ANI) analysis between </a:t>
            </a:r>
            <a:r>
              <a:rPr lang="en-US" sz="1100" i="1" dirty="0">
                <a:latin typeface="Arial" charset="0"/>
                <a:ea typeface="Arial" charset="0"/>
                <a:cs typeface="Arial" charset="0"/>
              </a:rPr>
              <a:t>Gemmobacter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sp. LW1 and </a:t>
            </a:r>
            <a:r>
              <a:rPr lang="en-US" sz="1100" i="1" dirty="0">
                <a:latin typeface="Arial" charset="0"/>
                <a:ea typeface="Arial" charset="0"/>
                <a:cs typeface="Arial" charset="0"/>
              </a:rPr>
              <a:t>Gemmobacter caeni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, </a:t>
            </a:r>
            <a:r>
              <a:rPr lang="en-US" sz="1100" i="1" dirty="0">
                <a:latin typeface="Arial" charset="0"/>
                <a:ea typeface="Arial" charset="0"/>
                <a:cs typeface="Arial" charset="0"/>
              </a:rPr>
              <a:t>Gemmobacter aqualitis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, </a:t>
            </a:r>
            <a:r>
              <a:rPr lang="en-US" sz="1100" i="1" dirty="0">
                <a:latin typeface="Arial" charset="0"/>
                <a:ea typeface="Arial" charset="0"/>
                <a:cs typeface="Arial" charset="0"/>
              </a:rPr>
              <a:t>Gemmobacter nectariphilus,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sz="1100" i="1" dirty="0">
                <a:latin typeface="Arial" charset="0"/>
                <a:ea typeface="Arial" charset="0"/>
                <a:cs typeface="Arial" charset="0"/>
              </a:rPr>
              <a:t>Gemmobacter megaterium, Rhodobacter sphaeroides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and</a:t>
            </a:r>
            <a:r>
              <a:rPr lang="en-US" sz="1100" i="1" dirty="0">
                <a:latin typeface="Arial" charset="0"/>
                <a:ea typeface="Arial" charset="0"/>
                <a:cs typeface="Arial" charset="0"/>
              </a:rPr>
              <a:t> Paracoccus denitrificans</a:t>
            </a:r>
          </a:p>
        </p:txBody>
      </p:sp>
      <p:graphicFrame>
        <p:nvGraphicFramePr>
          <p:cNvPr id="7" name="Table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08081328"/>
              </p:ext>
            </p:extLst>
          </p:nvPr>
        </p:nvGraphicFramePr>
        <p:xfrm>
          <a:off x="546122" y="764704"/>
          <a:ext cx="9087401" cy="45872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310534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110981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110981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110981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110981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1110981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1110981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1110981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endParaRPr lang="en-US" sz="11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i="1" dirty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G.</a:t>
                      </a:r>
                      <a:r>
                        <a:rPr lang="en-US" sz="1100" i="1" baseline="0" dirty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 sp. </a:t>
                      </a:r>
                      <a:r>
                        <a:rPr lang="en-US" sz="1100" i="0" baseline="0" dirty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LW-1</a:t>
                      </a:r>
                      <a:endParaRPr lang="en-US" sz="1100" i="0" dirty="0">
                        <a:solidFill>
                          <a:schemeClr val="tx1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i="1" dirty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G.</a:t>
                      </a:r>
                      <a:r>
                        <a:rPr lang="en-US" sz="1100" i="1" baseline="0" dirty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 </a:t>
                      </a:r>
                      <a:r>
                        <a:rPr lang="en-US" sz="1100" i="1" baseline="0" dirty="0" err="1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caeni</a:t>
                      </a:r>
                      <a:endParaRPr lang="en-US" sz="1100" i="1" dirty="0">
                        <a:solidFill>
                          <a:schemeClr val="tx1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i="1" dirty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G. </a:t>
                      </a:r>
                      <a:r>
                        <a:rPr lang="en-US" sz="1100" i="1" dirty="0" err="1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aquatilis</a:t>
                      </a:r>
                      <a:endParaRPr lang="en-US" sz="1100" i="1" dirty="0">
                        <a:solidFill>
                          <a:schemeClr val="tx1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i="1" dirty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G.</a:t>
                      </a:r>
                      <a:r>
                        <a:rPr lang="en-US" sz="1100" i="1" baseline="0" dirty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 </a:t>
                      </a:r>
                      <a:r>
                        <a:rPr lang="en-US" sz="1100" i="1" baseline="0" dirty="0" err="1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nectariphilus</a:t>
                      </a:r>
                      <a:endParaRPr lang="en-US" sz="1100" i="1" dirty="0">
                        <a:solidFill>
                          <a:schemeClr val="tx1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i="1" dirty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G. </a:t>
                      </a:r>
                      <a:r>
                        <a:rPr lang="en-US" sz="1100" i="1" dirty="0" err="1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megaterium</a:t>
                      </a:r>
                      <a:endParaRPr lang="en-US" sz="1100" i="1" dirty="0">
                        <a:solidFill>
                          <a:schemeClr val="tx1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i="1" dirty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Rhodobacter sphaeroides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i="1" dirty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Paracoccus denitrificans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594360">
                <a:tc>
                  <a:txBody>
                    <a:bodyPr/>
                    <a:lstStyle/>
                    <a:p>
                      <a:r>
                        <a:rPr lang="en-US" sz="1100" b="1" i="1" dirty="0">
                          <a:latin typeface="Arial" charset="0"/>
                          <a:ea typeface="Arial" charset="0"/>
                          <a:cs typeface="Arial" charset="0"/>
                        </a:rPr>
                        <a:t>G</a:t>
                      </a:r>
                      <a:r>
                        <a:rPr lang="en-US" sz="1100" b="1" dirty="0">
                          <a:latin typeface="Arial" charset="0"/>
                          <a:ea typeface="Arial" charset="0"/>
                          <a:cs typeface="Arial" charset="0"/>
                        </a:rPr>
                        <a:t>.</a:t>
                      </a:r>
                      <a:r>
                        <a:rPr lang="en-US" sz="1100" b="1" baseline="0" dirty="0">
                          <a:latin typeface="Arial" charset="0"/>
                          <a:ea typeface="Arial" charset="0"/>
                          <a:cs typeface="Arial" charset="0"/>
                        </a:rPr>
                        <a:t> sp. LW-1</a:t>
                      </a:r>
                      <a:endParaRPr lang="en-US" sz="1100" b="1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en-US" sz="1100" dirty="0">
                        <a:solidFill>
                          <a:schemeClr val="tx1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98.62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80.01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78.72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77.51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77.91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77.67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594360">
                <a:tc>
                  <a:txBody>
                    <a:bodyPr/>
                    <a:lstStyle/>
                    <a:p>
                      <a:pPr marL="0" marR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i="1" dirty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G.</a:t>
                      </a:r>
                      <a:r>
                        <a:rPr lang="en-US" sz="1100" b="1" i="1" baseline="0" dirty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 </a:t>
                      </a:r>
                      <a:r>
                        <a:rPr lang="en-US" sz="1100" b="1" i="1" baseline="0" dirty="0" err="1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caeni</a:t>
                      </a:r>
                      <a:endParaRPr lang="en-US" sz="1100" b="1" i="1" dirty="0">
                        <a:solidFill>
                          <a:schemeClr val="tx1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  <a:p>
                      <a:endParaRPr lang="en-US" sz="1100" b="1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98.62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en-US" sz="1100" dirty="0">
                        <a:solidFill>
                          <a:schemeClr val="tx1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80.04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79.77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77.74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77.81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77.70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594360">
                <a:tc>
                  <a:txBody>
                    <a:bodyPr/>
                    <a:lstStyle/>
                    <a:p>
                      <a:pPr marL="0" marR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i="1" dirty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G. </a:t>
                      </a:r>
                      <a:r>
                        <a:rPr lang="en-US" sz="1100" b="1" i="1" dirty="0" err="1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aquatilis</a:t>
                      </a:r>
                      <a:endParaRPr lang="en-US" sz="1100" b="1" i="1" dirty="0">
                        <a:solidFill>
                          <a:schemeClr val="tx1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80.01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80.04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en-US" sz="1100" dirty="0">
                        <a:solidFill>
                          <a:schemeClr val="tx1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77.97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77.73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77.89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77.11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594360">
                <a:tc>
                  <a:txBody>
                    <a:bodyPr/>
                    <a:lstStyle/>
                    <a:p>
                      <a:pPr marL="0" marR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i="1" dirty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G.</a:t>
                      </a:r>
                      <a:r>
                        <a:rPr lang="en-US" sz="1100" b="1" i="1" baseline="0" dirty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 </a:t>
                      </a:r>
                      <a:r>
                        <a:rPr lang="en-US" sz="1100" b="1" i="1" baseline="0" dirty="0" err="1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nectariphilus</a:t>
                      </a:r>
                      <a:endParaRPr lang="en-US" sz="1100" b="1" i="1" dirty="0">
                        <a:solidFill>
                          <a:schemeClr val="tx1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78.72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79.77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77.97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en-US" sz="1100" dirty="0">
                        <a:solidFill>
                          <a:schemeClr val="tx1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82.82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77.74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78.37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594360">
                <a:tc>
                  <a:txBody>
                    <a:bodyPr/>
                    <a:lstStyle/>
                    <a:p>
                      <a:pPr marL="0" marR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i="1" dirty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G. </a:t>
                      </a:r>
                      <a:r>
                        <a:rPr lang="en-US" sz="1100" b="1" i="1" dirty="0" err="1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megaterium</a:t>
                      </a:r>
                      <a:endParaRPr lang="en-US" sz="1100" b="1" i="1" dirty="0">
                        <a:solidFill>
                          <a:schemeClr val="tx1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  <a:p>
                      <a:endParaRPr lang="en-US" sz="1100" b="1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77.51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77.74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77.73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82.82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en-US" sz="1100" dirty="0">
                        <a:solidFill>
                          <a:schemeClr val="tx1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77.36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77.78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594360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i="1" dirty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Rhodobacter sphaeroides</a:t>
                      </a:r>
                    </a:p>
                    <a:p>
                      <a:endParaRPr lang="en-US" sz="1100" b="1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77.91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77.81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77.89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77.74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77.36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en-US" sz="1100" dirty="0">
                        <a:solidFill>
                          <a:schemeClr val="tx1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78.42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594360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i="1" dirty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Paracoccus denitrificans</a:t>
                      </a:r>
                    </a:p>
                    <a:p>
                      <a:endParaRPr lang="en-US" sz="1100" b="1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77.67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77.70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77.11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78.37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77.78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78.42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en-US" sz="1100" dirty="0">
                        <a:solidFill>
                          <a:schemeClr val="tx1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068160248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473</Words>
  <Application>Microsoft Macintosh PowerPoint</Application>
  <PresentationFormat>A4 Paper (210x297 mm)</PresentationFormat>
  <Paragraphs>224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6" baseType="lpstr">
      <vt:lpstr>Arial</vt:lpstr>
      <vt:lpstr>Calibri</vt:lpstr>
      <vt:lpstr>Larissa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kroeber</dc:creator>
  <cp:lastModifiedBy>DK</cp:lastModifiedBy>
  <cp:revision>40</cp:revision>
  <cp:lastPrinted>2017-08-07T13:55:33Z</cp:lastPrinted>
  <dcterms:created xsi:type="dcterms:W3CDTF">2017-05-29T12:07:04Z</dcterms:created>
  <dcterms:modified xsi:type="dcterms:W3CDTF">2019-08-01T13:59:49Z</dcterms:modified>
</cp:coreProperties>
</file>